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EBC68-693C-44FB-A552-F166587A78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6C804-1345-40A9-9658-12E4C9E635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58A95-FFE2-4893-8A53-747F17B3E4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AC363-FF51-452B-B499-7CA4C51D4F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DB59A-2BB2-406E-8637-772410189A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3813E-1BA9-4F40-8F9B-2C37591C29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23C177-F65C-4B2E-AFA0-DDE97C2EA9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3E2E9-F76C-4DF5-BC73-8646468C89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D27AB-E33E-452D-A2DF-C9A9C9CDEA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69AA8-F414-444A-A1E6-5A19E8A65E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E4B18-421B-4DC9-B861-1C20AC05AD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C5DD0-38EB-42A2-B694-47ACDEA2F3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F8C7EF-7C70-4C05-9491-CD4754A35436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4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47640" y="1285920"/>
          <a:ext cx="6121440" cy="3522600"/>
        </p:xfrm>
        <a:graphic>
          <a:graphicData uri="http://schemas.openxmlformats.org/drawingml/2006/table">
            <a:tbl>
              <a:tblPr/>
              <a:tblGrid>
                <a:gridCol w="1008360"/>
                <a:gridCol w="2592360"/>
                <a:gridCol w="718920"/>
                <a:gridCol w="649440"/>
                <a:gridCol w="1152360"/>
              </a:tblGrid>
              <a:tr h="2865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rm 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pulation cou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udy cou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justed </a:t>
                      </a:r>
                      <a:r>
                        <a:rPr b="1" i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valu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28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ological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230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intracellular signaling pathway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6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.54E-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704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cycl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5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2.94E-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81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metabolic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52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3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7.57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485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negative regulation of biological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2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02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513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division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2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03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724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intracellular signaling casca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9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03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998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ular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85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4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03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711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DNA conformation chang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2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4408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ular component biogenesi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5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45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639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RNA process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2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60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91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urine nucleoside monophosphate metabolic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88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compon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6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racellular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1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47E-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432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ganell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65E-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299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cromolecular complex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1E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6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5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E-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19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mbrane-enclosed lume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8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lecular Func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4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nding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9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4E-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 Box 194"/>
          <p:cNvSpPr/>
          <p:nvPr/>
        </p:nvSpPr>
        <p:spPr>
          <a:xfrm>
            <a:off x="735120" y="907920"/>
            <a:ext cx="765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4. Over-represented gene ontology categories of the down-regulated genes in heat shock treated RIF-1 cell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직사각형 5"/>
          <p:cNvSpPr/>
          <p:nvPr/>
        </p:nvSpPr>
        <p:spPr>
          <a:xfrm>
            <a:off x="1500120" y="4873680"/>
            <a:ext cx="624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*Common categories of down-regulated genes in heat shock and MG132 treated RIF-1 cell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1:51:57Z</dcterms:modified>
  <cp:revision>199</cp:revision>
  <dc:subject/>
  <dc:title>슬라이드 1</dc:title>
</cp:coreProperties>
</file>